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216650" cy="8686800"/>
  <p:notesSz cx="5943600" cy="82296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E88A8-505E-41DA-91BC-013BE325F0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C6F69-8313-48A1-8B1F-9E1777C341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5D235-AEB4-4A9C-86D8-321C4FC309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20284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95360" y="202716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1068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20284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95360" y="5021640"/>
            <a:ext cx="18018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FB972-ED0D-4EB8-B8C9-33C6531054A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934B2B-E224-4E28-A114-C2D7D5B5D4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D5EEC-7DAE-4820-9FED-79C927F247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665498-EED7-4F31-918E-3FCDB94579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9A3B8-A44C-4D46-8D72-8C6D808FB1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10680" y="347400"/>
            <a:ext cx="5596200" cy="6711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08023-17BD-448D-92F8-CC2C8BCEB5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CB27BB-618B-4FBA-9E66-D834E749CC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78080" y="502164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C3F867-469A-41E9-BEFA-49A32749CB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106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78080" y="2027160"/>
            <a:ext cx="27306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10680" y="5021640"/>
            <a:ext cx="5596200" cy="2734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0C7F62-EC4B-4EF7-929F-6B8FFFD6F9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10680" y="347400"/>
            <a:ext cx="5596200" cy="1447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10680" y="2027160"/>
            <a:ext cx="5596200" cy="5732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1068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123640" y="8051400"/>
            <a:ext cx="197028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455720" y="8051400"/>
            <a:ext cx="1451160" cy="461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70CB0A0-9272-4E0A-BFBA-213710A699D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1"/>
          <p:cNvSpPr/>
          <p:nvPr/>
        </p:nvSpPr>
        <p:spPr>
          <a:xfrm>
            <a:off x="0" y="221400"/>
            <a:ext cx="6218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 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Table S3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Calibri"/>
              </a:rPr>
              <a:t>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1"/>
          <p:cNvSpPr/>
          <p:nvPr/>
        </p:nvSpPr>
        <p:spPr>
          <a:xfrm>
            <a:off x="0" y="6980040"/>
            <a:ext cx="6218280" cy="160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Summary of subgroup analysis with Bonferroni’s Multiple Comparison test under each experimental condition.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^ p&lt;0.05 *p&lt;0.01 ** p&lt;0.00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SCADD and CPT2/MTPD fibroblasts were significantly different when compared to controls under all 4 experimental condition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SCADD was significantly different to MCADD fibroblasts, but not to CPT2/MTP under all 4 experimental conditions. MCADD was not significantly different to 625A/A controls under all 4 experimental conditions. MCADD survived significantly longer than 625G/G and 625 G/A controls only under physiological conditions. 625A/A controls were significantly different to 625G/G and G/A controls only under physiological condition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214200" y="609480"/>
          <a:ext cx="5761080" cy="6286680"/>
        </p:xfrm>
        <a:graphic>
          <a:graphicData uri="http://schemas.openxmlformats.org/drawingml/2006/table">
            <a:tbl>
              <a:tblPr/>
              <a:tblGrid>
                <a:gridCol w="1295640"/>
                <a:gridCol w="1143000"/>
                <a:gridCol w="1218960"/>
                <a:gridCol w="1067040"/>
                <a:gridCol w="1036440"/>
              </a:tblGrid>
              <a:tr h="52524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50μM Menadion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hysiological condi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7° C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 With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9° C  No Gluco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ean ± SE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         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         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        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3 ± 11.3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3± 17.9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16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         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**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SCADD           (n=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3.2 ± 8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9.9 ± 5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7.9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2.7 ± 2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       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        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3 ± 11.3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3± 17.9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16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PT2/MTPD  (n=12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0.9 ± 1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7.1 ± 10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34.3 ± 8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26.6 ± 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       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        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3 ± 11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3± 17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MCADD         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05.3 ± 11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37.3± 17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106.0 ± 11.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70.5 ± 20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       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280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5028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25A/A controls (n=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6.3 ± 2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6.5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14.8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05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 23.0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84.8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±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22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5320"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Controls         (n=9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48.4 ± 9.3^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83.4 ± 3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65.6 ± 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1680" rIns="31680" tIns="0" bIns="0" anchor="t">
                      <a:noAutofit/>
                    </a:bodyPr>
                    <a:p>
                      <a:pPr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43.8 ± 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1680" marR="3168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11T22:39:26Z</dcterms:created>
  <dc:creator>keith cunningham</dc:creator>
  <dc:description/>
  <dc:language>en-US</dc:language>
  <cp:lastModifiedBy>Ingrid Tein</cp:lastModifiedBy>
  <cp:lastPrinted>2011-01-27T01:12:00Z</cp:lastPrinted>
  <dcterms:modified xsi:type="dcterms:W3CDTF">2011-02-25T22:38:47Z</dcterms:modified>
  <cp:revision>33</cp:revision>
  <dc:subject/>
  <dc:title>Slide 1</dc:title>
</cp:coreProperties>
</file>